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olf, Jan van der" initials="WJvd" lastIdx="1" clrIdx="0">
    <p:extLst>
      <p:ext uri="{19B8F6BF-5375-455C-9EA6-DF929625EA0E}">
        <p15:presenceInfo xmlns:p15="http://schemas.microsoft.com/office/powerpoint/2012/main" userId="Wolf, Jan van d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2EF75DE-F673-4C32-AC1A-A54E922882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87447C21-918A-4784-9F4E-463D10B003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7236A98E-E02B-4E3D-AC13-3E4CBA238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E516A-2A46-4057-AB58-DF475F3D9699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A1A8747B-291E-4089-B7C5-FA6A28AD1E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5A70BB2C-90F5-415C-AA97-57BA3E974B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A6804-4D01-47F3-A814-E12A30FCE1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689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641684D-5278-49F3-969E-B3DD8E2A2B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CF77CC03-8752-40D2-86D4-F7986D7FE8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ABCC2CFE-8197-4E13-BCAB-7664AD4FD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E516A-2A46-4057-AB58-DF475F3D9699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24175E37-7D38-43D3-AE68-1F3E7178CC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E0309A43-D8E3-4EB6-8943-D5319EEB79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A6804-4D01-47F3-A814-E12A30FCE1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555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DE605F4A-4ADD-4A24-B776-2A273271F2C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F7AABF9E-12E7-4419-AC7A-D548730BF4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9064A709-7CE3-4690-9CC9-C4A9631159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E516A-2A46-4057-AB58-DF475F3D9699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1121FA27-BCC0-4CFF-9EBF-CCE9C8C56A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94F07DE4-8F7C-4052-9128-4800C1DEE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A6804-4D01-47F3-A814-E12A30FCE1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8212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4698B0C-76A0-4191-839C-CF35AD963C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E38A590F-D862-4DC4-89A2-F48588EF39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CC11F28E-5D1A-4610-B053-71F72FA299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E516A-2A46-4057-AB58-DF475F3D9699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0013F76E-6B17-477D-B174-C92626E59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F8902F26-7CA3-4CE9-B1B3-33D873152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A6804-4D01-47F3-A814-E12A30FCE1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8358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07DC9B2-0EDA-45E6-95A4-7A75D57B1E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CE9D029E-438C-4623-B924-F6CA4C535B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C8861034-07B4-42EB-9147-24971BD191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E516A-2A46-4057-AB58-DF475F3D9699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956001DC-B5C2-4FA0-A7ED-2A1CE8AC7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0886933A-4C08-4892-98CD-05FFB5F141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A6804-4D01-47F3-A814-E12A30FCE1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0462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DB58C88-963E-4ECD-953F-C49D5CCF31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4ECC57D8-7976-48C3-B00D-942F2CD169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AFE33749-2626-4FF6-B90A-243E5198BF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DD9A869B-5538-4568-93A4-CA62A05BC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E516A-2A46-4057-AB58-DF475F3D9699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D42F6D55-43C3-41CA-855E-357F5939FB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75244753-CC54-4030-932A-AFF5DEE66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A6804-4D01-47F3-A814-E12A30FCE1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5392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D1E8586-3E90-4E57-8A02-EEC109F702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12994687-AA42-4473-B7FE-5F5490C52F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EB289E9B-CC2D-4AFE-901E-C9F3E08B7A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BD3F4D5E-CFEA-42B0-AA59-6A762B3D55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712FBE49-E6BA-4453-B6E5-DBAF4DEB8A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02FD0A43-25C6-4125-A0BE-EA34EA5710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E516A-2A46-4057-AB58-DF475F3D9699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4A0B2A6A-F8B4-49CA-BD63-07E588427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F37F78A1-C3F1-4620-B8A3-F1614888FB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A6804-4D01-47F3-A814-E12A30FCE1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6260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D8C86AF-735C-4F88-81BF-B7023F332D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44F095E1-25C8-4186-9DA1-542FDFD21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E516A-2A46-4057-AB58-DF475F3D9699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A27840F7-86CB-4F0A-BC91-6B7D53F791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3DC0E4C5-FCDE-4FF2-A60A-A5352046B0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A6804-4D01-47F3-A814-E12A30FCE1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2241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7C59B5D3-6D89-494B-A570-F17902D632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E516A-2A46-4057-AB58-DF475F3D9699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B20BBD1F-3BD5-47A8-81A4-ADB838F82D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174D4761-9749-4025-9609-8C41F9845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A6804-4D01-47F3-A814-E12A30FCE1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88613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ADCD534-D79B-4A1A-B4EF-5C76A5EEE2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6B79C3F-B0E0-4B2B-BEE9-CEFB3BCB6F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146FF9BC-E71B-4835-8E08-4CE113C3D7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1368B887-FB97-48E0-A70D-8B6F2E4FEF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E516A-2A46-4057-AB58-DF475F3D9699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4E82727D-CE7A-4AE4-AD20-5A0B1E6D2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ACB63A5D-5FD5-434D-AD20-EE0928CBB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A6804-4D01-47F3-A814-E12A30FCE1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284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A7EC2A9-6BC9-4513-9F13-0737F461A8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6E17C715-A935-46FC-AE7B-E4620B9837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B2E21563-BF5B-48BD-B111-D77A816546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522D880C-7A85-46A4-8059-BBFDA41A62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E516A-2A46-4057-AB58-DF475F3D9699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24FAAFFE-D827-485F-A369-22085EFDE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866E067D-6471-4F07-B99C-B7723B96B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A6804-4D01-47F3-A814-E12A30FCE1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67704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8F6A7237-8441-4647-A015-4FB2C51728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GB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D76E7C16-C995-4454-857C-CB13250238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5837618E-3A1D-44CB-BB30-154DC9397A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E516A-2A46-4057-AB58-DF475F3D9699}" type="datetimeFigureOut">
              <a:rPr lang="en-GB" smtClean="0"/>
              <a:t>21/12/2022</a:t>
            </a:fld>
            <a:endParaRPr lang="en-GB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1B509B33-7F54-4021-A555-93B3F8EF17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F62D3DD5-08C8-4761-BE5A-CF60C27283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A6804-4D01-47F3-A814-E12A30FCE1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3499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42B9C9-173C-4BE6-AB06-A4BD7EF764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58830" y="405765"/>
            <a:ext cx="6456680" cy="1325563"/>
          </a:xfrm>
        </p:spPr>
        <p:txBody>
          <a:bodyPr>
            <a:normAutofit/>
          </a:bodyPr>
          <a:lstStyle/>
          <a:p>
            <a:r>
              <a:rPr lang="en-US" sz="1200" dirty="0">
                <a:latin typeface="Verdana" panose="020B0604030504040204" pitchFamily="34" charset="0"/>
                <a:ea typeface="Verdana" panose="020B0604030504040204" pitchFamily="34" charset="0"/>
              </a:rPr>
              <a:t>Fig</a:t>
            </a:r>
            <a:r>
              <a:rPr lang="en-US" altLang="zh-CN" sz="1200" dirty="0">
                <a:latin typeface="Verdana" panose="020B0604030504040204" pitchFamily="34" charset="0"/>
                <a:ea typeface="Verdana" panose="020B0604030504040204" pitchFamily="34" charset="0"/>
              </a:rPr>
              <a:t>ure</a:t>
            </a:r>
            <a:r>
              <a:rPr lang="en-US" sz="1200" dirty="0">
                <a:latin typeface="Verdana" panose="020B0604030504040204" pitchFamily="34" charset="0"/>
                <a:ea typeface="Verdana" panose="020B0604030504040204" pitchFamily="34" charset="0"/>
              </a:rPr>
              <a:t> S2. Amplification plots of a multiplex TaqMan assay for simultaneous detection of </a:t>
            </a:r>
            <a:r>
              <a:rPr lang="en-US" sz="1200" i="1" dirty="0">
                <a:latin typeface="Verdana" panose="020B0604030504040204" pitchFamily="34" charset="0"/>
                <a:ea typeface="Verdana" panose="020B0604030504040204" pitchFamily="34" charset="0"/>
              </a:rPr>
              <a:t>Dickeya</a:t>
            </a:r>
            <a:r>
              <a:rPr lang="en-US" sz="1200" dirty="0">
                <a:latin typeface="Verdana" panose="020B0604030504040204" pitchFamily="34" charset="0"/>
                <a:ea typeface="Verdana" panose="020B0604030504040204" pitchFamily="34" charset="0"/>
              </a:rPr>
              <a:t> sp. </a:t>
            </a:r>
            <a:r>
              <a:rPr lang="en-US" sz="1200" i="1" dirty="0">
                <a:latin typeface="Verdana" panose="020B0604030504040204" pitchFamily="34" charset="0"/>
                <a:ea typeface="Verdana" panose="020B0604030504040204" pitchFamily="34" charset="0"/>
              </a:rPr>
              <a:t>Pectobacterium atrosepticum</a:t>
            </a:r>
            <a:r>
              <a:rPr lang="en-US" sz="1200" dirty="0">
                <a:latin typeface="Verdana" panose="020B0604030504040204" pitchFamily="34" charset="0"/>
                <a:ea typeface="Verdana" panose="020B0604030504040204" pitchFamily="34" charset="0"/>
              </a:rPr>
              <a:t>, </a:t>
            </a:r>
            <a:r>
              <a:rPr lang="en-US" sz="1200" i="1" dirty="0">
                <a:latin typeface="Verdana" panose="020B0604030504040204" pitchFamily="34" charset="0"/>
                <a:ea typeface="Verdana" panose="020B0604030504040204" pitchFamily="34" charset="0"/>
              </a:rPr>
              <a:t>P. parmentieri </a:t>
            </a:r>
            <a:r>
              <a:rPr lang="en-US" sz="1200" dirty="0">
                <a:latin typeface="Verdana" panose="020B0604030504040204" pitchFamily="34" charset="0"/>
                <a:ea typeface="Verdana" panose="020B0604030504040204" pitchFamily="34" charset="0"/>
              </a:rPr>
              <a:t>and </a:t>
            </a:r>
            <a:r>
              <a:rPr lang="en-US" sz="1200" i="1" dirty="0">
                <a:latin typeface="Verdana" panose="020B0604030504040204" pitchFamily="34" charset="0"/>
                <a:ea typeface="Verdana" panose="020B0604030504040204" pitchFamily="34" charset="0"/>
              </a:rPr>
              <a:t>P. brasiliense </a:t>
            </a:r>
            <a:r>
              <a:rPr lang="en-US" sz="1200" dirty="0">
                <a:latin typeface="Verdana" panose="020B0604030504040204" pitchFamily="34" charset="0"/>
                <a:ea typeface="Verdana" panose="020B0604030504040204" pitchFamily="34" charset="0"/>
              </a:rPr>
              <a:t>using a ten-fold serial dilution (1 to 1.000.000 copies) of the four </a:t>
            </a:r>
            <a:r>
              <a:rPr lang="en-US" sz="1200" dirty="0" err="1">
                <a:latin typeface="Verdana" panose="020B0604030504040204" pitchFamily="34" charset="0"/>
                <a:ea typeface="Verdana" panose="020B0604030504040204" pitchFamily="34" charset="0"/>
              </a:rPr>
              <a:t>gBlocks</a:t>
            </a:r>
            <a:r>
              <a:rPr lang="en-US" sz="1200" dirty="0">
                <a:latin typeface="Verdana" panose="020B0604030504040204" pitchFamily="34" charset="0"/>
                <a:ea typeface="Verdana" panose="020B0604030504040204" pitchFamily="34" charset="0"/>
              </a:rPr>
              <a:t> comprising the target sequences, resulting in four plots per dilution. All four target probes were labelled with FAM.</a:t>
            </a:r>
            <a:endParaRPr lang="nl-NL" sz="1200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24E801D-786F-436F-B695-6538FFA2FE8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47" t="26587" r="42436" b="24520"/>
          <a:stretch/>
        </p:blipFill>
        <p:spPr>
          <a:xfrm>
            <a:off x="985519" y="1539966"/>
            <a:ext cx="6629991" cy="3261360"/>
          </a:xfrm>
          <a:prstGeom prst="rect">
            <a:avLst/>
          </a:prstGeom>
        </p:spPr>
      </p:pic>
      <p:sp>
        <p:nvSpPr>
          <p:cNvPr id="4" name="Tekstvak 3">
            <a:extLst>
              <a:ext uri="{FF2B5EF4-FFF2-40B4-BE49-F238E27FC236}">
                <a16:creationId xmlns:a16="http://schemas.microsoft.com/office/drawing/2014/main" id="{619ECFB5-1343-4343-87BC-CA164F4EDD3A}"/>
              </a:ext>
            </a:extLst>
          </p:cNvPr>
          <p:cNvSpPr txBox="1"/>
          <p:nvPr/>
        </p:nvSpPr>
        <p:spPr>
          <a:xfrm>
            <a:off x="5943600" y="2024131"/>
            <a:ext cx="7518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10</a:t>
            </a:r>
            <a:r>
              <a:rPr lang="en-GB" sz="1200" baseline="30000" dirty="0">
                <a:latin typeface="Verdana" panose="020B0604030504040204" pitchFamily="34" charset="0"/>
                <a:ea typeface="Verdana" panose="020B0604030504040204" pitchFamily="34" charset="0"/>
              </a:rPr>
              <a:t>6</a:t>
            </a:r>
            <a:endParaRPr lang="en-GB" sz="1200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sp>
        <p:nvSpPr>
          <p:cNvPr id="5" name="Tekstvak 4">
            <a:extLst>
              <a:ext uri="{FF2B5EF4-FFF2-40B4-BE49-F238E27FC236}">
                <a16:creationId xmlns:a16="http://schemas.microsoft.com/office/drawing/2014/main" id="{55FA5FF5-A34D-4FC6-9885-9CC932D6429C}"/>
              </a:ext>
            </a:extLst>
          </p:cNvPr>
          <p:cNvSpPr txBox="1"/>
          <p:nvPr/>
        </p:nvSpPr>
        <p:spPr>
          <a:xfrm>
            <a:off x="6207760" y="2601823"/>
            <a:ext cx="7518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10</a:t>
            </a:r>
            <a:r>
              <a:rPr lang="en-GB" sz="1200" baseline="30000" dirty="0">
                <a:latin typeface="Verdana" panose="020B0604030504040204" pitchFamily="34" charset="0"/>
                <a:ea typeface="Verdana" panose="020B0604030504040204" pitchFamily="34" charset="0"/>
              </a:rPr>
              <a:t>5</a:t>
            </a:r>
            <a:endParaRPr lang="en-GB" sz="1200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sp>
        <p:nvSpPr>
          <p:cNvPr id="6" name="Tekstvak 5">
            <a:extLst>
              <a:ext uri="{FF2B5EF4-FFF2-40B4-BE49-F238E27FC236}">
                <a16:creationId xmlns:a16="http://schemas.microsoft.com/office/drawing/2014/main" id="{59CAED05-E6E6-423E-A260-B048E2F6863B}"/>
              </a:ext>
            </a:extLst>
          </p:cNvPr>
          <p:cNvSpPr txBox="1"/>
          <p:nvPr/>
        </p:nvSpPr>
        <p:spPr>
          <a:xfrm>
            <a:off x="6471920" y="2966155"/>
            <a:ext cx="7518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10</a:t>
            </a:r>
            <a:r>
              <a:rPr lang="en-GB" sz="1200" baseline="30000" dirty="0">
                <a:latin typeface="Verdana" panose="020B0604030504040204" pitchFamily="34" charset="0"/>
                <a:ea typeface="Verdana" panose="020B0604030504040204" pitchFamily="34" charset="0"/>
              </a:rPr>
              <a:t>4</a:t>
            </a:r>
            <a:endParaRPr lang="en-GB" sz="1200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sp>
        <p:nvSpPr>
          <p:cNvPr id="7" name="Tekstvak 6">
            <a:extLst>
              <a:ext uri="{FF2B5EF4-FFF2-40B4-BE49-F238E27FC236}">
                <a16:creationId xmlns:a16="http://schemas.microsoft.com/office/drawing/2014/main" id="{C8195365-25F1-4A46-80BB-064A1CC164BE}"/>
              </a:ext>
            </a:extLst>
          </p:cNvPr>
          <p:cNvSpPr txBox="1"/>
          <p:nvPr/>
        </p:nvSpPr>
        <p:spPr>
          <a:xfrm>
            <a:off x="6736080" y="3411767"/>
            <a:ext cx="7518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10</a:t>
            </a:r>
            <a:r>
              <a:rPr lang="en-GB" sz="1200" baseline="30000" dirty="0">
                <a:latin typeface="Verdana" panose="020B0604030504040204" pitchFamily="34" charset="0"/>
                <a:ea typeface="Verdana" panose="020B0604030504040204" pitchFamily="34" charset="0"/>
              </a:rPr>
              <a:t>3</a:t>
            </a:r>
            <a:endParaRPr lang="en-GB" sz="1200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sp>
        <p:nvSpPr>
          <p:cNvPr id="8" name="Tekstvak 7">
            <a:extLst>
              <a:ext uri="{FF2B5EF4-FFF2-40B4-BE49-F238E27FC236}">
                <a16:creationId xmlns:a16="http://schemas.microsoft.com/office/drawing/2014/main" id="{CC5B8309-0920-4861-A22B-2F94DF256D76}"/>
              </a:ext>
            </a:extLst>
          </p:cNvPr>
          <p:cNvSpPr txBox="1"/>
          <p:nvPr/>
        </p:nvSpPr>
        <p:spPr>
          <a:xfrm>
            <a:off x="6746240" y="3928499"/>
            <a:ext cx="7518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10</a:t>
            </a:r>
            <a:r>
              <a:rPr lang="en-GB" sz="1200" baseline="30000" dirty="0">
                <a:latin typeface="Verdana" panose="020B0604030504040204" pitchFamily="34" charset="0"/>
                <a:ea typeface="Verdana" panose="020B0604030504040204" pitchFamily="34" charset="0"/>
              </a:rPr>
              <a:t>2</a:t>
            </a:r>
            <a:endParaRPr lang="en-GB" sz="1200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sp>
        <p:nvSpPr>
          <p:cNvPr id="9" name="Tekstvak 8">
            <a:extLst>
              <a:ext uri="{FF2B5EF4-FFF2-40B4-BE49-F238E27FC236}">
                <a16:creationId xmlns:a16="http://schemas.microsoft.com/office/drawing/2014/main" id="{7BD5B8BC-7553-4B78-AA32-6C9E7F37A6FE}"/>
              </a:ext>
            </a:extLst>
          </p:cNvPr>
          <p:cNvSpPr txBox="1"/>
          <p:nvPr/>
        </p:nvSpPr>
        <p:spPr>
          <a:xfrm>
            <a:off x="7061200" y="3988031"/>
            <a:ext cx="7518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10</a:t>
            </a:r>
            <a:r>
              <a:rPr lang="en-GB" sz="1200" baseline="30000" dirty="0">
                <a:latin typeface="Verdana" panose="020B0604030504040204" pitchFamily="34" charset="0"/>
                <a:ea typeface="Verdana" panose="020B0604030504040204" pitchFamily="34" charset="0"/>
              </a:rPr>
              <a:t>1</a:t>
            </a:r>
          </a:p>
        </p:txBody>
      </p:sp>
      <p:sp>
        <p:nvSpPr>
          <p:cNvPr id="10" name="Tekstvak 9">
            <a:extLst>
              <a:ext uri="{FF2B5EF4-FFF2-40B4-BE49-F238E27FC236}">
                <a16:creationId xmlns:a16="http://schemas.microsoft.com/office/drawing/2014/main" id="{A5FF1846-F392-4280-82B7-0BCC02A0359D}"/>
              </a:ext>
            </a:extLst>
          </p:cNvPr>
          <p:cNvSpPr txBox="1"/>
          <p:nvPr/>
        </p:nvSpPr>
        <p:spPr>
          <a:xfrm>
            <a:off x="7152640" y="4128843"/>
            <a:ext cx="7518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Verdana" panose="020B0604030504040204" pitchFamily="34" charset="0"/>
                <a:ea typeface="Verdana" panose="020B0604030504040204" pitchFamily="34" charset="0"/>
              </a:rPr>
              <a:t>10</a:t>
            </a:r>
            <a:r>
              <a:rPr lang="en-GB" sz="1200" baseline="30000" dirty="0">
                <a:latin typeface="Verdana" panose="020B0604030504040204" pitchFamily="34" charset="0"/>
                <a:ea typeface="Verdana" panose="020B0604030504040204" pitchFamily="34" charset="0"/>
              </a:rPr>
              <a:t>0</a:t>
            </a:r>
          </a:p>
        </p:txBody>
      </p:sp>
    </p:spTree>
    <p:extLst>
      <p:ext uri="{BB962C8B-B14F-4D97-AF65-F5344CB8AC3E}">
        <p14:creationId xmlns:p14="http://schemas.microsoft.com/office/powerpoint/2010/main" val="1800029808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70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Verdana</vt:lpstr>
      <vt:lpstr>Kantoorthema</vt:lpstr>
      <vt:lpstr>Figure S2. Amplification plots of a multiplex TaqMan assay for simultaneous detection of Dickeya sp. Pectobacterium atrosepticum, P. parmentieri and P. brasiliense using a ten-fold serial dilution (1 to 1.000.000 copies) of the four gBlocks comprising the target sequences, resulting in four plots per dilution. All four target probes were labelled with FAM.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. S2. Amplification plots of a multiplex TaqMan assay for detection of Dickeya sp. Pectobacterium atrosepticum, P. parmentieri and P. brasiliense using a ten-fold serial dilution of gBlocks comprising the target sequences (.. To .. Copies)</dc:title>
  <dc:creator>Wolf, Jan van der</dc:creator>
  <cp:lastModifiedBy>MDPI</cp:lastModifiedBy>
  <cp:revision>6</cp:revision>
  <dcterms:created xsi:type="dcterms:W3CDTF">2021-06-07T09:18:47Z</dcterms:created>
  <dcterms:modified xsi:type="dcterms:W3CDTF">2022-12-21T07:58:23Z</dcterms:modified>
</cp:coreProperties>
</file>